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7" r:id="rId2"/>
    <p:sldId id="258" r:id="rId3"/>
  </p:sldIdLst>
  <p:sldSz cx="6119813" cy="80994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445" autoAdjust="0"/>
    <p:restoredTop sz="94660"/>
  </p:normalViewPr>
  <p:slideViewPr>
    <p:cSldViewPr snapToGrid="0">
      <p:cViewPr varScale="1">
        <p:scale>
          <a:sx n="70" d="100"/>
          <a:sy n="70" d="100"/>
        </p:scale>
        <p:origin x="273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tellysbil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1325531"/>
            <a:ext cx="5201841" cy="2819800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nb-NO" smtClean="0"/>
              <a:t>Klikk for å redigere tittelsti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4254073"/>
            <a:ext cx="4589860" cy="1955486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nb-NO" smtClean="0"/>
              <a:t>Klikk for å redigere undertittelstil i mal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EF8C17-DB18-4152-BAC6-0C2B894790E2}" type="datetimeFigureOut">
              <a:rPr lang="nb-NO" smtClean="0"/>
              <a:t>11.04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EF0FA-7E53-41D3-9C61-7B5643D5F62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9373305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Loddret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EF8C17-DB18-4152-BAC6-0C2B894790E2}" type="datetimeFigureOut">
              <a:rPr lang="nb-NO" smtClean="0"/>
              <a:t>11.04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EF0FA-7E53-41D3-9C61-7B5643D5F62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9771095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drett tit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431220"/>
            <a:ext cx="1319585" cy="6863888"/>
          </a:xfrm>
        </p:spPr>
        <p:txBody>
          <a:bodyPr vert="eaVert"/>
          <a:lstStyle/>
          <a:p>
            <a:r>
              <a:rPr lang="nb-NO" smtClean="0"/>
              <a:t>Klikk for å redigere tittelsti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431220"/>
            <a:ext cx="3882256" cy="6863888"/>
          </a:xfrm>
        </p:spPr>
        <p:txBody>
          <a:bodyPr vert="eaVert"/>
          <a:lstStyle/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EF8C17-DB18-4152-BAC6-0C2B894790E2}" type="datetimeFigureOut">
              <a:rPr lang="nb-NO" smtClean="0"/>
              <a:t>11.04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EF0FA-7E53-41D3-9C61-7B5643D5F62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3508813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tel og innho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EF8C17-DB18-4152-BAC6-0C2B894790E2}" type="datetimeFigureOut">
              <a:rPr lang="nb-NO" smtClean="0"/>
              <a:t>11.04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EF0FA-7E53-41D3-9C61-7B5643D5F62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5334783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Del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2019234"/>
            <a:ext cx="5278339" cy="3369135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nb-NO" smtClean="0"/>
              <a:t>Klikk for å redigere tittelsti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5420242"/>
            <a:ext cx="5278339" cy="1771749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 smtClean="0"/>
              <a:t>Rediger tekststiler i mal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EF8C17-DB18-4152-BAC6-0C2B894790E2}" type="datetimeFigureOut">
              <a:rPr lang="nb-NO" smtClean="0"/>
              <a:t>11.04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EF0FA-7E53-41D3-9C61-7B5643D5F62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3588330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nholdsdel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2156097"/>
            <a:ext cx="2600921" cy="5139011"/>
          </a:xfrm>
        </p:spPr>
        <p:txBody>
          <a:bodyPr/>
          <a:lstStyle/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2156097"/>
            <a:ext cx="2600921" cy="5139011"/>
          </a:xfrm>
        </p:spPr>
        <p:txBody>
          <a:bodyPr/>
          <a:lstStyle/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EF8C17-DB18-4152-BAC6-0C2B894790E2}" type="datetimeFigureOut">
              <a:rPr lang="nb-NO" smtClean="0"/>
              <a:t>11.04.2024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EF0FA-7E53-41D3-9C61-7B5643D5F62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8030730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31221"/>
            <a:ext cx="5278339" cy="1565514"/>
          </a:xfrm>
        </p:spPr>
        <p:txBody>
          <a:bodyPr/>
          <a:lstStyle/>
          <a:p>
            <a:r>
              <a:rPr lang="nb-NO" smtClean="0"/>
              <a:t>Klikk for å redigere tittelsti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1985485"/>
            <a:ext cx="2588967" cy="973055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nb-NO" smtClean="0"/>
              <a:t>Rediger tekststiler i mal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2958540"/>
            <a:ext cx="2588967" cy="4351567"/>
          </a:xfrm>
        </p:spPr>
        <p:txBody>
          <a:bodyPr/>
          <a:lstStyle/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1985485"/>
            <a:ext cx="2601718" cy="973055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nb-NO" smtClean="0"/>
              <a:t>Rediger tekststiler i mal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2958540"/>
            <a:ext cx="2601718" cy="4351567"/>
          </a:xfrm>
        </p:spPr>
        <p:txBody>
          <a:bodyPr/>
          <a:lstStyle/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EF8C17-DB18-4152-BAC6-0C2B894790E2}" type="datetimeFigureOut">
              <a:rPr lang="nb-NO" smtClean="0"/>
              <a:t>11.04.2024</a:t>
            </a:fld>
            <a:endParaRPr lang="nb-NO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EF0FA-7E53-41D3-9C61-7B5643D5F62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8461501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Bare tit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EF8C17-DB18-4152-BAC6-0C2B894790E2}" type="datetimeFigureOut">
              <a:rPr lang="nb-NO" smtClean="0"/>
              <a:t>11.04.2024</a:t>
            </a:fld>
            <a:endParaRPr lang="nb-NO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EF0FA-7E53-41D3-9C61-7B5643D5F62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3400460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EF8C17-DB18-4152-BAC6-0C2B894790E2}" type="datetimeFigureOut">
              <a:rPr lang="nb-NO" smtClean="0"/>
              <a:t>11.04.2024</a:t>
            </a:fld>
            <a:endParaRPr lang="nb-NO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EF0FA-7E53-41D3-9C61-7B5643D5F62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3576067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hold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39962"/>
            <a:ext cx="1973799" cy="1889866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nb-NO" smtClean="0"/>
              <a:t>Klikk for å redigere tittelsti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1166169"/>
            <a:ext cx="3098155" cy="5755841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29828"/>
            <a:ext cx="1973799" cy="4501556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nb-NO" smtClean="0"/>
              <a:t>Rediger tekststiler i mal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EF8C17-DB18-4152-BAC6-0C2B894790E2}" type="datetimeFigureOut">
              <a:rPr lang="nb-NO" smtClean="0"/>
              <a:t>11.04.2024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EF0FA-7E53-41D3-9C61-7B5643D5F62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2386839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e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39962"/>
            <a:ext cx="1973799" cy="1889866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nb-NO" smtClean="0"/>
              <a:t>Klikk for å redigere tittelsti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1166169"/>
            <a:ext cx="3098155" cy="5755841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nb-NO" smtClean="0"/>
              <a:t>Klikk ikonet for å legge til et bild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29828"/>
            <a:ext cx="1973799" cy="4501556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nb-NO" smtClean="0"/>
              <a:t>Rediger tekststiler i mal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EF8C17-DB18-4152-BAC6-0C2B894790E2}" type="datetimeFigureOut">
              <a:rPr lang="nb-NO" smtClean="0"/>
              <a:t>11.04.2024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EF0FA-7E53-41D3-9C61-7B5643D5F62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2902854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431221"/>
            <a:ext cx="5278339" cy="156551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 smtClean="0"/>
              <a:t>Klikk for å redigere tittelsti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2156097"/>
            <a:ext cx="5278339" cy="513901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7506969"/>
            <a:ext cx="1376958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EF8C17-DB18-4152-BAC6-0C2B894790E2}" type="datetimeFigureOut">
              <a:rPr lang="nb-NO" smtClean="0"/>
              <a:t>11.04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7506969"/>
            <a:ext cx="2065437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7506969"/>
            <a:ext cx="1376958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1EF0FA-7E53-41D3-9C61-7B5643D5F62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7057174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Bilde 1"/>
          <p:cNvPicPr>
            <a:picLocks noChangeAspect="1"/>
          </p:cNvPicPr>
          <p:nvPr/>
        </p:nvPicPr>
        <p:blipFill rotWithShape="1">
          <a:blip r:embed="rId2"/>
          <a:srcRect l="7352" t="24535" r="3533"/>
          <a:stretch/>
        </p:blipFill>
        <p:spPr>
          <a:xfrm>
            <a:off x="672771" y="554269"/>
            <a:ext cx="4566905" cy="1326813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cxnSp>
        <p:nvCxnSpPr>
          <p:cNvPr id="3" name="Rett linje 2"/>
          <p:cNvCxnSpPr/>
          <p:nvPr/>
        </p:nvCxnSpPr>
        <p:spPr>
          <a:xfrm>
            <a:off x="2558883" y="551226"/>
            <a:ext cx="7363" cy="185641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4" name="Rektangel 3"/>
          <p:cNvSpPr/>
          <p:nvPr/>
        </p:nvSpPr>
        <p:spPr>
          <a:xfrm>
            <a:off x="591282" y="1856398"/>
            <a:ext cx="2108269" cy="2831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defTabSz="809976"/>
            <a:r>
              <a:rPr lang="nb-NO" sz="12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TAAAATTTCTTCCTTACG</a:t>
            </a:r>
          </a:p>
        </p:txBody>
      </p:sp>
      <p:sp>
        <p:nvSpPr>
          <p:cNvPr id="5" name="Rektangel 4"/>
          <p:cNvSpPr/>
          <p:nvPr/>
        </p:nvSpPr>
        <p:spPr>
          <a:xfrm>
            <a:off x="2497937" y="1849940"/>
            <a:ext cx="2823229" cy="4708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defTabSz="809976"/>
            <a:r>
              <a:rPr lang="nb-NO" sz="1230" dirty="0" smtClean="0">
                <a:solidFill>
                  <a:schemeClr val="accent1">
                    <a:lumMod val="75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ATGAGTTGGAACATTTGCAGTATAAG</a:t>
            </a:r>
            <a:r>
              <a:rPr lang="nb-NO" sz="1230" dirty="0" smtClean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lang="nb-NO" sz="123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defTabSz="809976"/>
            <a:r>
              <a:rPr lang="nb-NO" sz="123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CATTAGAAATCAACACAGATGGCTGTA</a:t>
            </a:r>
            <a:r>
              <a:rPr lang="nb-NO" sz="123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pic>
        <p:nvPicPr>
          <p:cNvPr id="6" name="Bilde 5"/>
          <p:cNvPicPr>
            <a:picLocks noChangeAspect="1"/>
          </p:cNvPicPr>
          <p:nvPr/>
        </p:nvPicPr>
        <p:blipFill rotWithShape="1">
          <a:blip r:embed="rId3"/>
          <a:srcRect l="7733" t="19992" r="9841"/>
          <a:stretch/>
        </p:blipFill>
        <p:spPr>
          <a:xfrm>
            <a:off x="669295" y="2809180"/>
            <a:ext cx="4557761" cy="1279807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cxnSp>
        <p:nvCxnSpPr>
          <p:cNvPr id="7" name="Rett linje 6"/>
          <p:cNvCxnSpPr/>
          <p:nvPr/>
        </p:nvCxnSpPr>
        <p:spPr>
          <a:xfrm flipH="1">
            <a:off x="2550211" y="2809180"/>
            <a:ext cx="16373" cy="1776553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8" name="Rektangel 7"/>
          <p:cNvSpPr/>
          <p:nvPr/>
        </p:nvSpPr>
        <p:spPr>
          <a:xfrm>
            <a:off x="578438" y="4091315"/>
            <a:ext cx="2108269" cy="2831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defTabSz="809976"/>
            <a:r>
              <a:rPr lang="nb-NO" sz="1240" dirty="0">
                <a:solidFill>
                  <a:schemeClr val="accent1">
                    <a:lumMod val="75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CAAATGTTCCAACTCATTC</a:t>
            </a:r>
          </a:p>
        </p:txBody>
      </p:sp>
      <p:sp>
        <p:nvSpPr>
          <p:cNvPr id="9" name="TekstSylinder 8"/>
          <p:cNvSpPr txBox="1"/>
          <p:nvPr/>
        </p:nvSpPr>
        <p:spPr>
          <a:xfrm>
            <a:off x="588196" y="292123"/>
            <a:ext cx="1378904" cy="2831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809976">
              <a:defRPr/>
            </a:pPr>
            <a:r>
              <a:rPr lang="nb-NO" sz="1240" kern="0" dirty="0">
                <a:solidFill>
                  <a:prstClr val="black"/>
                </a:solidFill>
              </a:rPr>
              <a:t>Forward </a:t>
            </a:r>
            <a:r>
              <a:rPr lang="nb-NO" sz="1240" kern="0" dirty="0" err="1">
                <a:solidFill>
                  <a:prstClr val="black"/>
                </a:solidFill>
              </a:rPr>
              <a:t>sequence</a:t>
            </a:r>
            <a:endParaRPr lang="nb-NO" sz="1240" kern="0" dirty="0">
              <a:solidFill>
                <a:prstClr val="black"/>
              </a:solidFill>
            </a:endParaRPr>
          </a:p>
        </p:txBody>
      </p:sp>
      <p:sp>
        <p:nvSpPr>
          <p:cNvPr id="10" name="TekstSylinder 9"/>
          <p:cNvSpPr txBox="1"/>
          <p:nvPr/>
        </p:nvSpPr>
        <p:spPr>
          <a:xfrm>
            <a:off x="581469" y="2534470"/>
            <a:ext cx="1348446" cy="2831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809976">
              <a:defRPr/>
            </a:pPr>
            <a:r>
              <a:rPr lang="nb-NO" sz="1240" kern="0" dirty="0" err="1">
                <a:solidFill>
                  <a:prstClr val="black"/>
                </a:solidFill>
              </a:rPr>
              <a:t>Reverse</a:t>
            </a:r>
            <a:r>
              <a:rPr lang="nb-NO" sz="1240" kern="0" dirty="0">
                <a:solidFill>
                  <a:prstClr val="black"/>
                </a:solidFill>
              </a:rPr>
              <a:t> </a:t>
            </a:r>
            <a:r>
              <a:rPr lang="nb-NO" sz="1240" kern="0" dirty="0" err="1">
                <a:solidFill>
                  <a:prstClr val="black"/>
                </a:solidFill>
              </a:rPr>
              <a:t>sequence</a:t>
            </a:r>
            <a:endParaRPr lang="nb-NO" sz="1240" kern="0" dirty="0">
              <a:solidFill>
                <a:prstClr val="black"/>
              </a:solidFill>
            </a:endParaRPr>
          </a:p>
        </p:txBody>
      </p:sp>
      <p:sp>
        <p:nvSpPr>
          <p:cNvPr id="11" name="Rektangel 10"/>
          <p:cNvSpPr/>
          <p:nvPr/>
        </p:nvSpPr>
        <p:spPr>
          <a:xfrm>
            <a:off x="2490771" y="4088683"/>
            <a:ext cx="2781531" cy="47397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defTabSz="809976"/>
            <a:r>
              <a:rPr lang="nb-NO" sz="124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GTAAGGAAGAAATTTTATTCTGCAT </a:t>
            </a:r>
          </a:p>
          <a:p>
            <a:pPr defTabSz="809976"/>
            <a:r>
              <a:rPr lang="nb-NO" sz="124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TTTATTGGAGTTTGAGGTCCCCCTT</a:t>
            </a:r>
            <a:r>
              <a:rPr lang="nb-NO" sz="124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12" name="TekstSylinder 11"/>
          <p:cNvSpPr txBox="1"/>
          <p:nvPr/>
        </p:nvSpPr>
        <p:spPr>
          <a:xfrm>
            <a:off x="591283" y="2051774"/>
            <a:ext cx="623889" cy="2559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063" dirty="0" err="1"/>
              <a:t>Exon</a:t>
            </a:r>
            <a:r>
              <a:rPr lang="nb-NO" sz="1063" dirty="0"/>
              <a:t> 10</a:t>
            </a:r>
          </a:p>
        </p:txBody>
      </p:sp>
      <p:sp>
        <p:nvSpPr>
          <p:cNvPr id="13" name="TekstSylinder 12"/>
          <p:cNvSpPr txBox="1"/>
          <p:nvPr/>
        </p:nvSpPr>
        <p:spPr>
          <a:xfrm>
            <a:off x="5192152" y="1865093"/>
            <a:ext cx="623889" cy="2559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063" dirty="0" err="1">
                <a:solidFill>
                  <a:schemeClr val="accent1">
                    <a:lumMod val="75000"/>
                  </a:schemeClr>
                </a:solidFill>
              </a:rPr>
              <a:t>Exon</a:t>
            </a:r>
            <a:r>
              <a:rPr lang="nb-NO" sz="1063" dirty="0">
                <a:solidFill>
                  <a:schemeClr val="accent1">
                    <a:lumMod val="75000"/>
                  </a:schemeClr>
                </a:solidFill>
              </a:rPr>
              <a:t> 11</a:t>
            </a:r>
          </a:p>
        </p:txBody>
      </p:sp>
      <p:sp>
        <p:nvSpPr>
          <p:cNvPr id="14" name="TekstSylinder 13"/>
          <p:cNvSpPr txBox="1"/>
          <p:nvPr/>
        </p:nvSpPr>
        <p:spPr>
          <a:xfrm>
            <a:off x="3591970" y="2247873"/>
            <a:ext cx="1752403" cy="2559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063" dirty="0" err="1">
                <a:solidFill>
                  <a:srgbClr val="FF0000"/>
                </a:solidFill>
              </a:rPr>
              <a:t>Intron</a:t>
            </a:r>
            <a:r>
              <a:rPr lang="nb-NO" sz="1063" dirty="0">
                <a:solidFill>
                  <a:srgbClr val="FF0000"/>
                </a:solidFill>
              </a:rPr>
              <a:t> 10 (from c.1037+310)</a:t>
            </a:r>
          </a:p>
        </p:txBody>
      </p:sp>
      <p:sp>
        <p:nvSpPr>
          <p:cNvPr id="16" name="TekstSylinder 15"/>
          <p:cNvSpPr txBox="1"/>
          <p:nvPr/>
        </p:nvSpPr>
        <p:spPr>
          <a:xfrm>
            <a:off x="578438" y="4300283"/>
            <a:ext cx="623889" cy="2559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063" dirty="0" err="1">
                <a:solidFill>
                  <a:schemeClr val="accent1">
                    <a:lumMod val="75000"/>
                  </a:schemeClr>
                </a:solidFill>
              </a:rPr>
              <a:t>Exon</a:t>
            </a:r>
            <a:r>
              <a:rPr lang="nb-NO" sz="1063" dirty="0">
                <a:solidFill>
                  <a:schemeClr val="accent1">
                    <a:lumMod val="75000"/>
                  </a:schemeClr>
                </a:solidFill>
              </a:rPr>
              <a:t> 11</a:t>
            </a:r>
          </a:p>
        </p:txBody>
      </p:sp>
      <p:sp>
        <p:nvSpPr>
          <p:cNvPr id="17" name="TekstSylinder 16"/>
          <p:cNvSpPr txBox="1"/>
          <p:nvPr/>
        </p:nvSpPr>
        <p:spPr>
          <a:xfrm>
            <a:off x="3384655" y="4462496"/>
            <a:ext cx="1752403" cy="2559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063" dirty="0" err="1">
                <a:solidFill>
                  <a:srgbClr val="FF0000"/>
                </a:solidFill>
              </a:rPr>
              <a:t>Intron</a:t>
            </a:r>
            <a:r>
              <a:rPr lang="nb-NO" sz="1063" dirty="0">
                <a:solidFill>
                  <a:srgbClr val="FF0000"/>
                </a:solidFill>
              </a:rPr>
              <a:t> 10 (from c.1037+519)</a:t>
            </a:r>
          </a:p>
        </p:txBody>
      </p:sp>
      <p:sp>
        <p:nvSpPr>
          <p:cNvPr id="18" name="TekstSylinder 17"/>
          <p:cNvSpPr txBox="1"/>
          <p:nvPr/>
        </p:nvSpPr>
        <p:spPr>
          <a:xfrm>
            <a:off x="5014833" y="4095187"/>
            <a:ext cx="623889" cy="2559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063" dirty="0" err="1"/>
              <a:t>Exon</a:t>
            </a:r>
            <a:r>
              <a:rPr lang="nb-NO" sz="1063" dirty="0"/>
              <a:t> 10</a:t>
            </a:r>
          </a:p>
        </p:txBody>
      </p:sp>
      <p:cxnSp>
        <p:nvCxnSpPr>
          <p:cNvPr id="20" name="Rett linje 19"/>
          <p:cNvCxnSpPr/>
          <p:nvPr/>
        </p:nvCxnSpPr>
        <p:spPr>
          <a:xfrm>
            <a:off x="646747" y="5545137"/>
            <a:ext cx="445791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Rektangel 20"/>
          <p:cNvSpPr/>
          <p:nvPr/>
        </p:nvSpPr>
        <p:spPr>
          <a:xfrm>
            <a:off x="854449" y="5416754"/>
            <a:ext cx="1119320" cy="28716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b-NO" sz="974" dirty="0" err="1">
                <a:solidFill>
                  <a:schemeClr val="tx1"/>
                </a:solidFill>
              </a:rPr>
              <a:t>exon</a:t>
            </a:r>
            <a:r>
              <a:rPr lang="nb-NO" sz="974" dirty="0">
                <a:solidFill>
                  <a:schemeClr val="tx1"/>
                </a:solidFill>
              </a:rPr>
              <a:t> 10</a:t>
            </a:r>
          </a:p>
        </p:txBody>
      </p:sp>
      <p:sp>
        <p:nvSpPr>
          <p:cNvPr id="22" name="Rektangel 21"/>
          <p:cNvSpPr/>
          <p:nvPr/>
        </p:nvSpPr>
        <p:spPr>
          <a:xfrm>
            <a:off x="4008440" y="5416754"/>
            <a:ext cx="985512" cy="287161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b-NO" sz="974" dirty="0" err="1">
                <a:solidFill>
                  <a:schemeClr val="accent1">
                    <a:lumMod val="75000"/>
                  </a:schemeClr>
                </a:solidFill>
              </a:rPr>
              <a:t>exon</a:t>
            </a:r>
            <a:r>
              <a:rPr lang="nb-NO" sz="974" dirty="0">
                <a:solidFill>
                  <a:schemeClr val="accent1">
                    <a:lumMod val="75000"/>
                  </a:schemeClr>
                </a:solidFill>
              </a:rPr>
              <a:t> 11</a:t>
            </a:r>
          </a:p>
        </p:txBody>
      </p:sp>
      <p:sp>
        <p:nvSpPr>
          <p:cNvPr id="23" name="Rektangel 22"/>
          <p:cNvSpPr/>
          <p:nvPr/>
        </p:nvSpPr>
        <p:spPr>
          <a:xfrm>
            <a:off x="2664675" y="5416754"/>
            <a:ext cx="722001" cy="287161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 sz="1416"/>
          </a:p>
        </p:txBody>
      </p:sp>
      <p:sp>
        <p:nvSpPr>
          <p:cNvPr id="24" name="TekstSylinder 23"/>
          <p:cNvSpPr txBox="1"/>
          <p:nvPr/>
        </p:nvSpPr>
        <p:spPr>
          <a:xfrm>
            <a:off x="646747" y="5117863"/>
            <a:ext cx="434734" cy="22865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nb-NO" sz="886" dirty="0"/>
              <a:t>c.935</a:t>
            </a:r>
          </a:p>
        </p:txBody>
      </p:sp>
      <p:sp>
        <p:nvSpPr>
          <p:cNvPr id="25" name="TekstSylinder 24"/>
          <p:cNvSpPr txBox="1"/>
          <p:nvPr/>
        </p:nvSpPr>
        <p:spPr>
          <a:xfrm>
            <a:off x="1744342" y="5106031"/>
            <a:ext cx="492443" cy="22865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nb-NO" sz="886" dirty="0"/>
              <a:t>c.1037</a:t>
            </a:r>
          </a:p>
        </p:txBody>
      </p:sp>
      <p:sp>
        <p:nvSpPr>
          <p:cNvPr id="26" name="TekstSylinder 25"/>
          <p:cNvSpPr txBox="1"/>
          <p:nvPr/>
        </p:nvSpPr>
        <p:spPr>
          <a:xfrm>
            <a:off x="2329293" y="5106031"/>
            <a:ext cx="721672" cy="22865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nb-NO" sz="886" dirty="0"/>
              <a:t>c.1037+310</a:t>
            </a:r>
          </a:p>
        </p:txBody>
      </p:sp>
      <p:sp>
        <p:nvSpPr>
          <p:cNvPr id="27" name="TekstSylinder 26"/>
          <p:cNvSpPr txBox="1"/>
          <p:nvPr/>
        </p:nvSpPr>
        <p:spPr>
          <a:xfrm>
            <a:off x="3022911" y="5106031"/>
            <a:ext cx="721672" cy="22865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nb-NO" sz="886" dirty="0"/>
              <a:t>c.1037+519</a:t>
            </a:r>
          </a:p>
        </p:txBody>
      </p:sp>
      <p:sp>
        <p:nvSpPr>
          <p:cNvPr id="28" name="TekstSylinder 27"/>
          <p:cNvSpPr txBox="1"/>
          <p:nvPr/>
        </p:nvSpPr>
        <p:spPr>
          <a:xfrm>
            <a:off x="3793977" y="5106031"/>
            <a:ext cx="492443" cy="22865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nb-NO" sz="886" dirty="0"/>
              <a:t>c.1038</a:t>
            </a:r>
          </a:p>
        </p:txBody>
      </p:sp>
      <p:sp>
        <p:nvSpPr>
          <p:cNvPr id="29" name="TekstSylinder 28"/>
          <p:cNvSpPr txBox="1"/>
          <p:nvPr/>
        </p:nvSpPr>
        <p:spPr>
          <a:xfrm>
            <a:off x="4763294" y="5106031"/>
            <a:ext cx="492443" cy="22865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nb-NO" sz="886" dirty="0"/>
              <a:t>c.1230</a:t>
            </a:r>
          </a:p>
        </p:txBody>
      </p:sp>
      <p:cxnSp>
        <p:nvCxnSpPr>
          <p:cNvPr id="30" name="Rett linje 29"/>
          <p:cNvCxnSpPr>
            <a:stCxn id="24" idx="2"/>
          </p:cNvCxnSpPr>
          <p:nvPr/>
        </p:nvCxnSpPr>
        <p:spPr>
          <a:xfrm flipH="1">
            <a:off x="852915" y="5346515"/>
            <a:ext cx="11199" cy="8207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Rett linje 30"/>
          <p:cNvCxnSpPr/>
          <p:nvPr/>
        </p:nvCxnSpPr>
        <p:spPr>
          <a:xfrm flipH="1">
            <a:off x="4007691" y="5328202"/>
            <a:ext cx="1278" cy="9262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Rett linje 31"/>
          <p:cNvCxnSpPr/>
          <p:nvPr/>
        </p:nvCxnSpPr>
        <p:spPr>
          <a:xfrm flipH="1">
            <a:off x="4994622" y="5326416"/>
            <a:ext cx="1278" cy="9262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Rett linje 32"/>
          <p:cNvCxnSpPr/>
          <p:nvPr/>
        </p:nvCxnSpPr>
        <p:spPr>
          <a:xfrm flipH="1">
            <a:off x="2659723" y="5323691"/>
            <a:ext cx="1278" cy="9262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Rett linje 33"/>
          <p:cNvCxnSpPr/>
          <p:nvPr/>
        </p:nvCxnSpPr>
        <p:spPr>
          <a:xfrm flipH="1">
            <a:off x="1968006" y="5323691"/>
            <a:ext cx="1278" cy="9262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Rett linje 34"/>
          <p:cNvCxnSpPr/>
          <p:nvPr/>
        </p:nvCxnSpPr>
        <p:spPr>
          <a:xfrm flipH="1">
            <a:off x="3384649" y="5317985"/>
            <a:ext cx="1278" cy="9262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kstSylinder 35"/>
          <p:cNvSpPr txBox="1"/>
          <p:nvPr/>
        </p:nvSpPr>
        <p:spPr>
          <a:xfrm>
            <a:off x="2634230" y="5422460"/>
            <a:ext cx="806631" cy="242246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nb-NO" sz="974" dirty="0" err="1">
                <a:solidFill>
                  <a:srgbClr val="FF0000"/>
                </a:solidFill>
              </a:rPr>
              <a:t>pseudoexon</a:t>
            </a:r>
            <a:endParaRPr lang="nb-NO" sz="974" dirty="0">
              <a:solidFill>
                <a:srgbClr val="FF0000"/>
              </a:solidFill>
            </a:endParaRPr>
          </a:p>
        </p:txBody>
      </p:sp>
      <p:pic>
        <p:nvPicPr>
          <p:cNvPr id="40" name="Bilde 39"/>
          <p:cNvPicPr>
            <a:picLocks noChangeAspect="1"/>
          </p:cNvPicPr>
          <p:nvPr/>
        </p:nvPicPr>
        <p:blipFill rotWithShape="1">
          <a:blip r:embed="rId4"/>
          <a:srcRect l="6248" t="15094" r="11854"/>
          <a:stretch/>
        </p:blipFill>
        <p:spPr>
          <a:xfrm>
            <a:off x="637394" y="6257373"/>
            <a:ext cx="4615697" cy="135982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1" name="Rektangel 40"/>
          <p:cNvSpPr/>
          <p:nvPr/>
        </p:nvSpPr>
        <p:spPr>
          <a:xfrm>
            <a:off x="592772" y="7624177"/>
            <a:ext cx="2108269" cy="2831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nb-NO" sz="1240" dirty="0">
                <a:latin typeface="Courier New" panose="02070309020205020404" pitchFamily="49" charset="0"/>
                <a:cs typeface="Courier New" panose="02070309020205020404" pitchFamily="49" charset="0"/>
              </a:rPr>
              <a:t>AATAAAATTTCTTCCTTACG</a:t>
            </a:r>
          </a:p>
        </p:txBody>
      </p:sp>
      <p:sp>
        <p:nvSpPr>
          <p:cNvPr id="42" name="Rektangel 41"/>
          <p:cNvSpPr/>
          <p:nvPr/>
        </p:nvSpPr>
        <p:spPr>
          <a:xfrm>
            <a:off x="2508041" y="7617199"/>
            <a:ext cx="3048779" cy="2831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nb-NO" sz="1240" dirty="0">
                <a:solidFill>
                  <a:schemeClr val="accent1">
                    <a:lumMod val="75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ATGAGTTGGAACATTTGCAGTATAAG</a:t>
            </a:r>
          </a:p>
        </p:txBody>
      </p:sp>
      <p:sp>
        <p:nvSpPr>
          <p:cNvPr id="44" name="TekstSylinder 43"/>
          <p:cNvSpPr txBox="1"/>
          <p:nvPr/>
        </p:nvSpPr>
        <p:spPr>
          <a:xfrm rot="16200000">
            <a:off x="66990" y="6830444"/>
            <a:ext cx="729880" cy="3102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416" dirty="0"/>
              <a:t>Control</a:t>
            </a:r>
          </a:p>
        </p:txBody>
      </p:sp>
      <p:sp>
        <p:nvSpPr>
          <p:cNvPr id="45" name="TekstSylinder 44"/>
          <p:cNvSpPr txBox="1"/>
          <p:nvPr/>
        </p:nvSpPr>
        <p:spPr>
          <a:xfrm>
            <a:off x="540450" y="5978580"/>
            <a:ext cx="1373581" cy="2831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240" dirty="0"/>
              <a:t>Forward </a:t>
            </a:r>
            <a:r>
              <a:rPr lang="nb-NO" sz="1240" dirty="0" err="1"/>
              <a:t>sequence</a:t>
            </a:r>
            <a:endParaRPr lang="nb-NO" sz="1240" dirty="0"/>
          </a:p>
        </p:txBody>
      </p:sp>
      <p:sp>
        <p:nvSpPr>
          <p:cNvPr id="46" name="TekstSylinder 45"/>
          <p:cNvSpPr txBox="1"/>
          <p:nvPr/>
        </p:nvSpPr>
        <p:spPr>
          <a:xfrm>
            <a:off x="592773" y="7814505"/>
            <a:ext cx="623889" cy="2559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063" dirty="0" err="1"/>
              <a:t>Exon</a:t>
            </a:r>
            <a:r>
              <a:rPr lang="nb-NO" sz="1063" dirty="0"/>
              <a:t> 10</a:t>
            </a:r>
          </a:p>
        </p:txBody>
      </p:sp>
      <p:sp>
        <p:nvSpPr>
          <p:cNvPr id="47" name="TekstSylinder 46"/>
          <p:cNvSpPr txBox="1"/>
          <p:nvPr/>
        </p:nvSpPr>
        <p:spPr>
          <a:xfrm>
            <a:off x="4720484" y="7792708"/>
            <a:ext cx="623889" cy="2559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063" dirty="0" err="1">
                <a:solidFill>
                  <a:schemeClr val="accent1">
                    <a:lumMod val="75000"/>
                  </a:schemeClr>
                </a:solidFill>
              </a:rPr>
              <a:t>Exon</a:t>
            </a:r>
            <a:r>
              <a:rPr lang="nb-NO" sz="1063" dirty="0">
                <a:solidFill>
                  <a:schemeClr val="accent1">
                    <a:lumMod val="75000"/>
                  </a:schemeClr>
                </a:solidFill>
              </a:rPr>
              <a:t> 11</a:t>
            </a:r>
          </a:p>
        </p:txBody>
      </p:sp>
      <p:cxnSp>
        <p:nvCxnSpPr>
          <p:cNvPr id="48" name="Rett linje 47"/>
          <p:cNvCxnSpPr/>
          <p:nvPr/>
        </p:nvCxnSpPr>
        <p:spPr>
          <a:xfrm flipH="1">
            <a:off x="2568682" y="6242332"/>
            <a:ext cx="15185" cy="1647486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50" name="TekstSylinder 49"/>
          <p:cNvSpPr txBox="1"/>
          <p:nvPr/>
        </p:nvSpPr>
        <p:spPr>
          <a:xfrm>
            <a:off x="216427" y="492024"/>
            <a:ext cx="325730" cy="3102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416" dirty="0"/>
              <a:t>a)</a:t>
            </a:r>
          </a:p>
        </p:txBody>
      </p:sp>
      <p:sp>
        <p:nvSpPr>
          <p:cNvPr id="51" name="TekstSylinder 50"/>
          <p:cNvSpPr txBox="1"/>
          <p:nvPr/>
        </p:nvSpPr>
        <p:spPr>
          <a:xfrm>
            <a:off x="216427" y="4844117"/>
            <a:ext cx="316112" cy="3102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416" dirty="0"/>
              <a:t>c)</a:t>
            </a:r>
          </a:p>
        </p:txBody>
      </p:sp>
      <p:sp>
        <p:nvSpPr>
          <p:cNvPr id="52" name="TekstSylinder 51"/>
          <p:cNvSpPr txBox="1"/>
          <p:nvPr/>
        </p:nvSpPr>
        <p:spPr>
          <a:xfrm>
            <a:off x="216427" y="6113726"/>
            <a:ext cx="335348" cy="3102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416" dirty="0"/>
              <a:t>d)</a:t>
            </a:r>
          </a:p>
        </p:txBody>
      </p:sp>
      <p:sp>
        <p:nvSpPr>
          <p:cNvPr id="53" name="TekstSylinder 52"/>
          <p:cNvSpPr txBox="1"/>
          <p:nvPr/>
        </p:nvSpPr>
        <p:spPr>
          <a:xfrm>
            <a:off x="216427" y="2652746"/>
            <a:ext cx="335348" cy="3102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416" dirty="0"/>
              <a:t>b)</a:t>
            </a:r>
          </a:p>
        </p:txBody>
      </p:sp>
    </p:spTree>
    <p:extLst>
      <p:ext uri="{BB962C8B-B14F-4D97-AF65-F5344CB8AC3E}">
        <p14:creationId xmlns:p14="http://schemas.microsoft.com/office/powerpoint/2010/main" val="30101690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ktangel 1"/>
          <p:cNvSpPr/>
          <p:nvPr/>
        </p:nvSpPr>
        <p:spPr>
          <a:xfrm>
            <a:off x="497121" y="419114"/>
            <a:ext cx="5077998" cy="14008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nb-NO" sz="1063" dirty="0" err="1" smtClean="0"/>
              <a:t>Additional</a:t>
            </a:r>
            <a:r>
              <a:rPr lang="nb-NO" sz="1063" dirty="0" smtClean="0"/>
              <a:t> file 2</a:t>
            </a:r>
            <a:r>
              <a:rPr lang="nb-NO" sz="1063" dirty="0" smtClean="0"/>
              <a:t>: </a:t>
            </a:r>
            <a:r>
              <a:rPr lang="nb-NO" sz="1063" dirty="0" err="1"/>
              <a:t>cDNA</a:t>
            </a:r>
            <a:r>
              <a:rPr lang="nb-NO" sz="1063" dirty="0"/>
              <a:t> </a:t>
            </a:r>
            <a:r>
              <a:rPr lang="nb-NO" sz="1063" dirty="0" err="1"/>
              <a:t>sequence</a:t>
            </a:r>
            <a:r>
              <a:rPr lang="nb-NO" sz="1063" dirty="0"/>
              <a:t> </a:t>
            </a:r>
            <a:r>
              <a:rPr lang="nb-NO" sz="1063" dirty="0" err="1"/>
              <a:t>of</a:t>
            </a:r>
            <a:r>
              <a:rPr lang="nb-NO" sz="1063" dirty="0"/>
              <a:t> </a:t>
            </a:r>
            <a:r>
              <a:rPr lang="nb-NO" sz="1063" i="1" dirty="0"/>
              <a:t>BBS7</a:t>
            </a:r>
            <a:r>
              <a:rPr lang="nb-NO" sz="1063" dirty="0"/>
              <a:t> </a:t>
            </a:r>
            <a:r>
              <a:rPr lang="nb-NO" sz="1063" dirty="0" err="1"/>
              <a:t>amplified</a:t>
            </a:r>
            <a:r>
              <a:rPr lang="nb-NO" sz="1063" dirty="0"/>
              <a:t> from </a:t>
            </a:r>
            <a:r>
              <a:rPr lang="nb-NO" sz="1063" dirty="0" err="1"/>
              <a:t>peripheral</a:t>
            </a:r>
            <a:r>
              <a:rPr lang="nb-NO" sz="1063" dirty="0"/>
              <a:t> </a:t>
            </a:r>
            <a:r>
              <a:rPr lang="nb-NO" sz="1063" dirty="0" err="1"/>
              <a:t>blood</a:t>
            </a:r>
            <a:r>
              <a:rPr lang="nb-NO" sz="1063" dirty="0"/>
              <a:t> </a:t>
            </a:r>
            <a:r>
              <a:rPr lang="nb-NO" sz="1063" dirty="0" err="1"/>
              <a:t>cells</a:t>
            </a:r>
            <a:r>
              <a:rPr lang="nb-NO" sz="1063" dirty="0"/>
              <a:t> </a:t>
            </a:r>
            <a:r>
              <a:rPr lang="nb-NO" sz="1063" dirty="0" err="1"/>
              <a:t>of</a:t>
            </a:r>
            <a:r>
              <a:rPr lang="nb-NO" sz="1063" dirty="0"/>
              <a:t> </a:t>
            </a:r>
            <a:r>
              <a:rPr lang="nb-NO" sz="1063" dirty="0" err="1"/>
              <a:t>the</a:t>
            </a:r>
            <a:r>
              <a:rPr lang="nb-NO" sz="1063" dirty="0"/>
              <a:t> </a:t>
            </a:r>
            <a:r>
              <a:rPr lang="nb-NO" sz="1063" dirty="0" err="1"/>
              <a:t>homozygous</a:t>
            </a:r>
            <a:r>
              <a:rPr lang="nb-NO" sz="1063" dirty="0"/>
              <a:t> </a:t>
            </a:r>
            <a:r>
              <a:rPr lang="nb-NO" sz="1063" dirty="0" err="1"/>
              <a:t>individual</a:t>
            </a:r>
            <a:r>
              <a:rPr lang="nb-NO" sz="1063" dirty="0"/>
              <a:t> </a:t>
            </a:r>
            <a:r>
              <a:rPr lang="nb-NO" sz="1063" dirty="0" err="1"/>
              <a:t>with</a:t>
            </a:r>
            <a:r>
              <a:rPr lang="nb-NO" sz="1063" dirty="0"/>
              <a:t> </a:t>
            </a:r>
            <a:r>
              <a:rPr lang="nb-NO" sz="1063" dirty="0" err="1"/>
              <a:t>the</a:t>
            </a:r>
            <a:r>
              <a:rPr lang="nb-NO" sz="1063" dirty="0"/>
              <a:t> variant c.1037+522_1037+523delinsAA.  The RT-PCR </a:t>
            </a:r>
            <a:r>
              <a:rPr lang="nb-NO" sz="1063" dirty="0" err="1"/>
              <a:t>was</a:t>
            </a:r>
            <a:r>
              <a:rPr lang="nb-NO" sz="1063" dirty="0"/>
              <a:t> </a:t>
            </a:r>
            <a:r>
              <a:rPr lang="nb-NO" sz="1063" dirty="0" err="1"/>
              <a:t>performed</a:t>
            </a:r>
            <a:r>
              <a:rPr lang="nb-NO" sz="1063" dirty="0"/>
              <a:t> </a:t>
            </a:r>
            <a:r>
              <a:rPr lang="nb-NO" sz="1063" dirty="0" err="1"/>
              <a:t>using</a:t>
            </a:r>
            <a:r>
              <a:rPr lang="nb-NO" sz="1063" dirty="0"/>
              <a:t> a forward primer in </a:t>
            </a:r>
            <a:r>
              <a:rPr lang="nb-NO" sz="1063" dirty="0" err="1"/>
              <a:t>exon</a:t>
            </a:r>
            <a:r>
              <a:rPr lang="nb-NO" sz="1063" dirty="0"/>
              <a:t> 9 (5’-TCTATCCAGGGTGGTTGTGTAGGA-3’) and a </a:t>
            </a:r>
            <a:r>
              <a:rPr lang="nb-NO" sz="1063" dirty="0" err="1"/>
              <a:t>reverse</a:t>
            </a:r>
            <a:r>
              <a:rPr lang="nb-NO" sz="1063" dirty="0"/>
              <a:t> primer in </a:t>
            </a:r>
            <a:r>
              <a:rPr lang="nb-NO" sz="1063" dirty="0" err="1"/>
              <a:t>exon</a:t>
            </a:r>
            <a:r>
              <a:rPr lang="nb-NO" sz="1063" dirty="0"/>
              <a:t> 12 (5’-GCTGCTAAAGCTAACAACAGCAGA-3’). </a:t>
            </a:r>
          </a:p>
          <a:p>
            <a:r>
              <a:rPr lang="nb-NO" sz="1063" dirty="0"/>
              <a:t>The </a:t>
            </a:r>
            <a:r>
              <a:rPr lang="nb-NO" sz="1063" dirty="0" err="1"/>
              <a:t>cDNA</a:t>
            </a:r>
            <a:r>
              <a:rPr lang="nb-NO" sz="1063" dirty="0"/>
              <a:t> </a:t>
            </a:r>
            <a:r>
              <a:rPr lang="nb-NO" sz="1063" dirty="0" err="1"/>
              <a:t>sequencing</a:t>
            </a:r>
            <a:r>
              <a:rPr lang="nb-NO" sz="1063" dirty="0"/>
              <a:t> </a:t>
            </a:r>
            <a:r>
              <a:rPr lang="nb-NO" sz="1063" dirty="0" err="1"/>
              <a:t>was</a:t>
            </a:r>
            <a:r>
              <a:rPr lang="nb-NO" sz="1063" dirty="0"/>
              <a:t> </a:t>
            </a:r>
            <a:r>
              <a:rPr lang="nb-NO" sz="1063" dirty="0" err="1"/>
              <a:t>performed</a:t>
            </a:r>
            <a:r>
              <a:rPr lang="nb-NO" sz="1063" dirty="0"/>
              <a:t> </a:t>
            </a:r>
            <a:r>
              <a:rPr lang="nb-NO" sz="1063" dirty="0" err="1"/>
              <a:t>using</a:t>
            </a:r>
            <a:r>
              <a:rPr lang="nb-NO" sz="1063" dirty="0"/>
              <a:t> </a:t>
            </a:r>
            <a:r>
              <a:rPr lang="nb-NO" sz="1063" dirty="0" err="1"/>
              <a:t>the</a:t>
            </a:r>
            <a:r>
              <a:rPr lang="nb-NO" sz="1063" dirty="0"/>
              <a:t> forward primer in a) and </a:t>
            </a:r>
            <a:r>
              <a:rPr lang="nb-NO" sz="1063" dirty="0" err="1"/>
              <a:t>the</a:t>
            </a:r>
            <a:r>
              <a:rPr lang="nb-NO" sz="1063" dirty="0"/>
              <a:t> </a:t>
            </a:r>
            <a:r>
              <a:rPr lang="nb-NO" sz="1063" dirty="0" err="1"/>
              <a:t>reverse</a:t>
            </a:r>
            <a:r>
              <a:rPr lang="nb-NO" sz="1063" dirty="0"/>
              <a:t> primer in b).</a:t>
            </a:r>
          </a:p>
          <a:p>
            <a:r>
              <a:rPr lang="nb-NO" sz="1063" dirty="0"/>
              <a:t>c) A </a:t>
            </a:r>
            <a:r>
              <a:rPr lang="nb-NO" sz="1063" dirty="0" err="1"/>
              <a:t>schematical</a:t>
            </a:r>
            <a:r>
              <a:rPr lang="nb-NO" sz="1063" dirty="0"/>
              <a:t> </a:t>
            </a:r>
            <a:r>
              <a:rPr lang="nb-NO" sz="1063" dirty="0" err="1"/>
              <a:t>illustration</a:t>
            </a:r>
            <a:r>
              <a:rPr lang="nb-NO" sz="1063" dirty="0"/>
              <a:t> </a:t>
            </a:r>
            <a:r>
              <a:rPr lang="nb-NO" sz="1063" dirty="0" err="1"/>
              <a:t>of</a:t>
            </a:r>
            <a:r>
              <a:rPr lang="nb-NO" sz="1063" dirty="0"/>
              <a:t> location </a:t>
            </a:r>
            <a:r>
              <a:rPr lang="nb-NO" sz="1063" dirty="0" err="1"/>
              <a:t>of</a:t>
            </a:r>
            <a:r>
              <a:rPr lang="nb-NO" sz="1063" dirty="0"/>
              <a:t> </a:t>
            </a:r>
            <a:r>
              <a:rPr lang="nb-NO" sz="1063" dirty="0" err="1"/>
              <a:t>the</a:t>
            </a:r>
            <a:r>
              <a:rPr lang="nb-NO" sz="1063" dirty="0"/>
              <a:t> </a:t>
            </a:r>
            <a:r>
              <a:rPr lang="nb-NO" sz="1063" dirty="0" err="1"/>
              <a:t>inserted</a:t>
            </a:r>
            <a:r>
              <a:rPr lang="nb-NO" sz="1063" dirty="0"/>
              <a:t> </a:t>
            </a:r>
            <a:r>
              <a:rPr lang="nb-NO" sz="1063" dirty="0" err="1"/>
              <a:t>pseudoexon</a:t>
            </a:r>
            <a:r>
              <a:rPr lang="nb-NO" sz="1063" dirty="0"/>
              <a:t>.</a:t>
            </a:r>
          </a:p>
          <a:p>
            <a:r>
              <a:rPr lang="nb-NO" sz="1063" dirty="0"/>
              <a:t>d) </a:t>
            </a:r>
            <a:r>
              <a:rPr lang="nb-NO" sz="1063" dirty="0" err="1"/>
              <a:t>cDNA</a:t>
            </a:r>
            <a:r>
              <a:rPr lang="nb-NO" sz="1063" dirty="0"/>
              <a:t> </a:t>
            </a:r>
            <a:r>
              <a:rPr lang="nb-NO" sz="1063" dirty="0" err="1"/>
              <a:t>sequence</a:t>
            </a:r>
            <a:r>
              <a:rPr lang="nb-NO" sz="1063" dirty="0"/>
              <a:t> </a:t>
            </a:r>
            <a:r>
              <a:rPr lang="nb-NO" sz="1063" dirty="0" err="1"/>
              <a:t>of</a:t>
            </a:r>
            <a:r>
              <a:rPr lang="nb-NO" sz="1063" dirty="0"/>
              <a:t> </a:t>
            </a:r>
            <a:r>
              <a:rPr lang="nb-NO" sz="1063" i="1" dirty="0"/>
              <a:t>BBS7</a:t>
            </a:r>
            <a:r>
              <a:rPr lang="nb-NO" sz="1063" dirty="0"/>
              <a:t> in a </a:t>
            </a:r>
            <a:r>
              <a:rPr lang="nb-NO" sz="1063" dirty="0" err="1"/>
              <a:t>control</a:t>
            </a:r>
            <a:r>
              <a:rPr lang="nb-NO" sz="1063" dirty="0"/>
              <a:t> sample.</a:t>
            </a:r>
          </a:p>
        </p:txBody>
      </p:sp>
    </p:spTree>
    <p:extLst>
      <p:ext uri="{BB962C8B-B14F-4D97-AF65-F5344CB8AC3E}">
        <p14:creationId xmlns:p14="http://schemas.microsoft.com/office/powerpoint/2010/main" val="14280061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tema">
  <a:themeElements>
    <a:clrScheme name="Office-t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0</TotalTime>
  <Words>150</Words>
  <Application>Microsoft Office PowerPoint</Application>
  <PresentationFormat>Egendefinert</PresentationFormat>
  <Paragraphs>37</Paragraphs>
  <Slides>2</Slides>
  <Notes>0</Notes>
  <HiddenSlides>0</HiddenSlides>
  <MMClips>0</MMClips>
  <ScaleCrop>false</ScaleCrop>
  <HeadingPairs>
    <vt:vector size="6" baseType="variant">
      <vt:variant>
        <vt:lpstr>Brukte skrifter</vt:lpstr>
      </vt:variant>
      <vt:variant>
        <vt:i4>4</vt:i4>
      </vt:variant>
      <vt:variant>
        <vt:lpstr>Tema</vt:lpstr>
      </vt:variant>
      <vt:variant>
        <vt:i4>1</vt:i4>
      </vt:variant>
      <vt:variant>
        <vt:lpstr>Lysbildetitler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Courier New</vt:lpstr>
      <vt:lpstr>Office-tema</vt:lpstr>
      <vt:lpstr>PowerPoint-presentasjon</vt:lpstr>
      <vt:lpstr>PowerPoint-presentasjon</vt:lpstr>
    </vt:vector>
  </TitlesOfParts>
  <Company>Helse Sør-Øs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sjon</dc:title>
  <dc:creator>Mari Ann Kulseth</dc:creator>
  <cp:lastModifiedBy>Cecilie Fremstad Rustad</cp:lastModifiedBy>
  <cp:revision>8</cp:revision>
  <dcterms:created xsi:type="dcterms:W3CDTF">2024-04-09T14:44:08Z</dcterms:created>
  <dcterms:modified xsi:type="dcterms:W3CDTF">2024-04-11T08:43:37Z</dcterms:modified>
</cp:coreProperties>
</file>